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  <p:sldId id="258" r:id="rId4"/>
    <p:sldId id="259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40" y="5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59D7524-9696-459B-AB6D-4ADB6F60D05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2ED11C4A-9549-4467-898A-158B2D212AC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7A11A3A-B6B6-4FA4-9D3E-97ACC92A83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84483-92E3-4146-B6F5-38B4EE68DFCB}" type="datetimeFigureOut">
              <a:rPr lang="zh-CN" altLang="en-US" smtClean="0"/>
              <a:t>2023/11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2286D6D-7821-40CB-BE82-079B42927F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484088B-6EC3-4326-B55E-77E86EC247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188B8-EB02-473D-8F5B-C32EE8B4CB7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8244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F37718B-832B-4322-ABB3-30B9D2C562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35B89FF-B45E-470A-88F7-BDDC60641A7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F9C19E4-98D3-43CE-AD23-A3524E40E6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84483-92E3-4146-B6F5-38B4EE68DFCB}" type="datetimeFigureOut">
              <a:rPr lang="zh-CN" altLang="en-US" smtClean="0"/>
              <a:t>2023/11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AC49894-62E6-44C2-8F51-658248B639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FED0771-9B1F-4AA2-BAC6-AF2947B696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188B8-EB02-473D-8F5B-C32EE8B4CB7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371328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1ED51CF-0850-4438-BA6A-E1855A3D5C2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16EF6AB-8B10-4EFE-8F0E-553A73A0393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2FF91A0-D680-4760-866B-34901F78EE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84483-92E3-4146-B6F5-38B4EE68DFCB}" type="datetimeFigureOut">
              <a:rPr lang="zh-CN" altLang="en-US" smtClean="0"/>
              <a:t>2023/11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59A9B71-AF77-4668-8375-23AA05D44F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D54783C-CC5B-49D9-8774-EB1837AE65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188B8-EB02-473D-8F5B-C32EE8B4CB7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16091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32EA14E-D2DD-4DE1-BF11-7BEB276834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C0EF540-187B-430E-B2C4-3AB01F787C0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141AC1A-EEFC-44E9-A8AF-99620AED8F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84483-92E3-4146-B6F5-38B4EE68DFCB}" type="datetimeFigureOut">
              <a:rPr lang="zh-CN" altLang="en-US" smtClean="0"/>
              <a:t>2023/11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12A32D5-81F1-4DBF-95CA-7665750BFE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EF89C2F-094A-442E-816A-2C9B000276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188B8-EB02-473D-8F5B-C32EE8B4CB7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5850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091B48F-85B2-4202-8313-50ECB05233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F7A80DC-3159-4366-8FF9-A2AEE9FBF6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E96F8C6-6508-4E83-BFB1-EB18783077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84483-92E3-4146-B6F5-38B4EE68DFCB}" type="datetimeFigureOut">
              <a:rPr lang="zh-CN" altLang="en-US" smtClean="0"/>
              <a:t>2023/11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C851D08-D2A5-42AF-9226-496BE3814F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838E9AF-AB40-4FD0-9E80-3AD66677A8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188B8-EB02-473D-8F5B-C32EE8B4CB7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20473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3C26914-3254-4BB4-9740-7CDDB1E4E2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0CE65A9-8683-451A-B55F-C9C6A4B2999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F200FC6-34DA-4341-B7DE-EB95382C3E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37CE950-2511-456D-BA15-D66D268E19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84483-92E3-4146-B6F5-38B4EE68DFCB}" type="datetimeFigureOut">
              <a:rPr lang="zh-CN" altLang="en-US" smtClean="0"/>
              <a:t>2023/11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1A3AB08-2BBD-47A6-8123-E06BD492FB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6FBCEEC-1291-4AAA-9DDF-9890E38B4D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188B8-EB02-473D-8F5B-C32EE8B4CB7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544575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DE38104-06E4-480C-BFF9-17E59B4DAA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C4D1DAD-3000-4BF0-9719-5ACAF53057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575A61E-D796-4E82-A8AA-887B4E848E0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810B8473-5F9C-4F67-B21A-C7BC5A23699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F5E2A99-F9AB-4168-97FE-5D5D883749E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756D173C-BBC2-4A76-BA20-E9D51011BA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84483-92E3-4146-B6F5-38B4EE68DFCB}" type="datetimeFigureOut">
              <a:rPr lang="zh-CN" altLang="en-US" smtClean="0"/>
              <a:t>2023/11/1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90AA5662-9F75-4E64-9FC3-5FF70F2E6F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7F9223BF-9A63-4162-A6E8-89AF492FE9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188B8-EB02-473D-8F5B-C32EE8B4CB7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95044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4ED163A-6F73-4807-AAC4-F26108AE02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C03CAE5E-8532-4AB6-BC61-8860AEAA9D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84483-92E3-4146-B6F5-38B4EE68DFCB}" type="datetimeFigureOut">
              <a:rPr lang="zh-CN" altLang="en-US" smtClean="0"/>
              <a:t>2023/11/1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C46DF227-1853-41CA-AFC5-CEF320E434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DE9AB5EC-C30A-417C-873C-F185AA78B2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188B8-EB02-473D-8F5B-C32EE8B4CB7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5800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80C9A9CA-6EB6-4DD2-AEAC-3DD1DF6241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84483-92E3-4146-B6F5-38B4EE68DFCB}" type="datetimeFigureOut">
              <a:rPr lang="zh-CN" altLang="en-US" smtClean="0"/>
              <a:t>2023/11/1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9957A808-9150-42F7-B384-4292D1EC7B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182F0F76-63C2-449A-A686-39A4263040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188B8-EB02-473D-8F5B-C32EE8B4CB7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22767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4C2E150-83F6-4E71-BFDD-58EFF57C5F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1FD61B3-51FA-4BA3-9210-04B35A13C9B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01689B0-CF33-4CD4-8417-FA675F1892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B61C44B-EC34-474F-B75A-CC1FF20185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84483-92E3-4146-B6F5-38B4EE68DFCB}" type="datetimeFigureOut">
              <a:rPr lang="zh-CN" altLang="en-US" smtClean="0"/>
              <a:t>2023/11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2251571-2DFE-4D43-A662-0657A56ED6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AE448A7-FC03-4E72-88D8-08791AA747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188B8-EB02-473D-8F5B-C32EE8B4CB7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24007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46809DC-4F85-438B-8DF3-907FA65682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C094C84-A9D8-4EBC-87ED-A86D87474BF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D6FE3DB-F4CB-4E5D-8EC2-5BB75DCB4D4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95979F7-CC24-4018-A85B-19CF0D1D5E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84483-92E3-4146-B6F5-38B4EE68DFCB}" type="datetimeFigureOut">
              <a:rPr lang="zh-CN" altLang="en-US" smtClean="0"/>
              <a:t>2023/11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4BB3FEB-F016-41DA-BC94-DAFD237BCC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B21EE60-8A8C-4203-93A7-1D83EAAA75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188B8-EB02-473D-8F5B-C32EE8B4CB7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77235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D96CCF33-A97D-4007-9FE7-4329B3C33B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720D9C5-0624-4659-AEB2-D93E223B24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32D20E7-6BB2-42EC-AA64-7BF3AF7E6CE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D84483-92E3-4146-B6F5-38B4EE68DFCB}" type="datetimeFigureOut">
              <a:rPr lang="zh-CN" altLang="en-US" smtClean="0"/>
              <a:t>2023/11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83BBFF6-4DFF-4847-ABCC-D3D93F23C20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EAA518C-01AB-475B-AA93-5706EB5ECD5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B188B8-EB02-473D-8F5B-C32EE8B4CB7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81470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9DAD6C10-1286-43D3-B1CE-1128461A9D6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54959" y="502005"/>
            <a:ext cx="5682082" cy="5853989"/>
          </a:xfrm>
          <a:prstGeom prst="rect">
            <a:avLst/>
          </a:prstGeom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id="{30908D53-4174-4AC3-9D3D-1F9FBA690484}"/>
              </a:ext>
            </a:extLst>
          </p:cNvPr>
          <p:cNvSpPr/>
          <p:nvPr/>
        </p:nvSpPr>
        <p:spPr>
          <a:xfrm>
            <a:off x="6479628" y="1403131"/>
            <a:ext cx="733096" cy="252248"/>
          </a:xfrm>
          <a:prstGeom prst="rect">
            <a:avLst/>
          </a:prstGeom>
          <a:noFill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" name="矩形 3">
            <a:extLst>
              <a:ext uri="{FF2B5EF4-FFF2-40B4-BE49-F238E27FC236}">
                <a16:creationId xmlns:a16="http://schemas.microsoft.com/office/drawing/2014/main" id="{8F26D041-CE2D-4ACA-9632-E69D2D649B2E}"/>
              </a:ext>
            </a:extLst>
          </p:cNvPr>
          <p:cNvSpPr/>
          <p:nvPr/>
        </p:nvSpPr>
        <p:spPr>
          <a:xfrm>
            <a:off x="6419193" y="4653471"/>
            <a:ext cx="733096" cy="252248"/>
          </a:xfrm>
          <a:prstGeom prst="rect">
            <a:avLst/>
          </a:prstGeom>
          <a:noFill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A27546C5-A096-44DF-9EE5-248B884B7F2E}"/>
              </a:ext>
            </a:extLst>
          </p:cNvPr>
          <p:cNvSpPr/>
          <p:nvPr/>
        </p:nvSpPr>
        <p:spPr>
          <a:xfrm>
            <a:off x="1081032" y="-106941"/>
            <a:ext cx="10676321" cy="92333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altLang="zh-CN" sz="5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Full unedited blot/gel for Figure 7F</a:t>
            </a:r>
            <a:endParaRPr lang="zh-CN" altLang="en-US" sz="5400" b="0" cap="none" spc="0" dirty="0">
              <a:ln w="0"/>
              <a:solidFill>
                <a:schemeClr val="accent1"/>
              </a:solidFill>
              <a:effectLst>
                <a:outerShdw blurRad="38100" dist="25400" dir="5400000" algn="ctr" rotWithShape="0">
                  <a:srgbClr val="6E747A">
                    <a:alpha val="43000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24151473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C5CDC15B-31D7-4F44-925F-DE8A756BEDB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08571" y="722720"/>
            <a:ext cx="5889041" cy="6067209"/>
          </a:xfrm>
          <a:prstGeom prst="rect">
            <a:avLst/>
          </a:prstGeom>
        </p:spPr>
      </p:pic>
      <p:sp>
        <p:nvSpPr>
          <p:cNvPr id="4" name="矩形 3">
            <a:extLst>
              <a:ext uri="{FF2B5EF4-FFF2-40B4-BE49-F238E27FC236}">
                <a16:creationId xmlns:a16="http://schemas.microsoft.com/office/drawing/2014/main" id="{B2129A88-9309-4975-B724-5012EB49A153}"/>
              </a:ext>
            </a:extLst>
          </p:cNvPr>
          <p:cNvSpPr/>
          <p:nvPr/>
        </p:nvSpPr>
        <p:spPr>
          <a:xfrm>
            <a:off x="5967249" y="1661815"/>
            <a:ext cx="733096" cy="252248"/>
          </a:xfrm>
          <a:prstGeom prst="rect">
            <a:avLst/>
          </a:prstGeom>
          <a:noFill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AD22A1FC-9EC5-48F6-AF25-FFA5CC0C4779}"/>
              </a:ext>
            </a:extLst>
          </p:cNvPr>
          <p:cNvSpPr/>
          <p:nvPr/>
        </p:nvSpPr>
        <p:spPr>
          <a:xfrm>
            <a:off x="5904187" y="5070061"/>
            <a:ext cx="733096" cy="252248"/>
          </a:xfrm>
          <a:prstGeom prst="rect">
            <a:avLst/>
          </a:prstGeom>
          <a:noFill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807C8913-199A-46EE-80DE-A34EAD94E12C}"/>
              </a:ext>
            </a:extLst>
          </p:cNvPr>
          <p:cNvSpPr/>
          <p:nvPr/>
        </p:nvSpPr>
        <p:spPr>
          <a:xfrm>
            <a:off x="796499" y="-106941"/>
            <a:ext cx="11245387" cy="92333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altLang="zh-CN" sz="5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Full unedited blot/gel for Figure S13E</a:t>
            </a:r>
            <a:endParaRPr lang="zh-CN" altLang="en-US" sz="5400" b="0" cap="none" spc="0" dirty="0">
              <a:ln w="0"/>
              <a:solidFill>
                <a:schemeClr val="accent1"/>
              </a:solidFill>
              <a:effectLst>
                <a:outerShdw blurRad="38100" dist="25400" dir="5400000" algn="ctr" rotWithShape="0">
                  <a:srgbClr val="6E747A">
                    <a:alpha val="43000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16344942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5AFD1136-0CC2-4EF9-9632-74D6F56D9F1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87752" y="1260348"/>
            <a:ext cx="7016496" cy="4337304"/>
          </a:xfrm>
          <a:prstGeom prst="rect">
            <a:avLst/>
          </a:prstGeom>
        </p:spPr>
      </p:pic>
      <p:sp>
        <p:nvSpPr>
          <p:cNvPr id="3" name="矩形 2">
            <a:extLst>
              <a:ext uri="{FF2B5EF4-FFF2-40B4-BE49-F238E27FC236}">
                <a16:creationId xmlns:a16="http://schemas.microsoft.com/office/drawing/2014/main" id="{521D84F5-E8DB-4A1F-8015-08C11DF5FF2C}"/>
              </a:ext>
            </a:extLst>
          </p:cNvPr>
          <p:cNvSpPr/>
          <p:nvPr/>
        </p:nvSpPr>
        <p:spPr>
          <a:xfrm>
            <a:off x="1081032" y="-106941"/>
            <a:ext cx="10676321" cy="92333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altLang="zh-CN" sz="5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Full unedited blot/gel for Figure 7F</a:t>
            </a:r>
            <a:endParaRPr lang="zh-CN" altLang="en-US" sz="5400" b="0" cap="none" spc="0" dirty="0">
              <a:ln w="0"/>
              <a:solidFill>
                <a:schemeClr val="accent1"/>
              </a:solidFill>
              <a:effectLst>
                <a:outerShdw blurRad="38100" dist="25400" dir="5400000" algn="ctr" rotWithShape="0">
                  <a:srgbClr val="6E747A">
                    <a:alpha val="43000"/>
                  </a:srgbClr>
                </a:outerShdw>
              </a:effectLst>
            </a:endParaRPr>
          </a:p>
        </p:txBody>
      </p:sp>
      <p:sp>
        <p:nvSpPr>
          <p:cNvPr id="4" name="矩形 3">
            <a:extLst>
              <a:ext uri="{FF2B5EF4-FFF2-40B4-BE49-F238E27FC236}">
                <a16:creationId xmlns:a16="http://schemas.microsoft.com/office/drawing/2014/main" id="{9E4613A6-8331-4AFE-B8B6-54695307F0A5}"/>
              </a:ext>
            </a:extLst>
          </p:cNvPr>
          <p:cNvSpPr/>
          <p:nvPr/>
        </p:nvSpPr>
        <p:spPr>
          <a:xfrm>
            <a:off x="4958256" y="2554014"/>
            <a:ext cx="733096" cy="252248"/>
          </a:xfrm>
          <a:prstGeom prst="rect">
            <a:avLst/>
          </a:prstGeom>
          <a:noFill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20727A54-9AFB-4452-B550-E45E5573BED2}"/>
              </a:ext>
            </a:extLst>
          </p:cNvPr>
          <p:cNvSpPr/>
          <p:nvPr/>
        </p:nvSpPr>
        <p:spPr>
          <a:xfrm>
            <a:off x="4958256" y="4272455"/>
            <a:ext cx="733096" cy="252248"/>
          </a:xfrm>
          <a:prstGeom prst="rect">
            <a:avLst/>
          </a:prstGeom>
          <a:noFill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2195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73A4E99F-3DE5-44EF-99CA-9F69BD96302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5556" y="1260348"/>
            <a:ext cx="5580888" cy="4337304"/>
          </a:xfrm>
          <a:prstGeom prst="rect">
            <a:avLst/>
          </a:prstGeom>
        </p:spPr>
      </p:pic>
      <p:sp>
        <p:nvSpPr>
          <p:cNvPr id="4" name="矩形 3">
            <a:extLst>
              <a:ext uri="{FF2B5EF4-FFF2-40B4-BE49-F238E27FC236}">
                <a16:creationId xmlns:a16="http://schemas.microsoft.com/office/drawing/2014/main" id="{C4016E15-4C03-4DFE-8F92-A98C1E9AD90B}"/>
              </a:ext>
            </a:extLst>
          </p:cNvPr>
          <p:cNvSpPr/>
          <p:nvPr/>
        </p:nvSpPr>
        <p:spPr>
          <a:xfrm>
            <a:off x="5729452" y="2286000"/>
            <a:ext cx="733096" cy="189186"/>
          </a:xfrm>
          <a:prstGeom prst="rect">
            <a:avLst/>
          </a:prstGeom>
          <a:noFill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24D02393-891B-468A-A383-4654D551D078}"/>
              </a:ext>
            </a:extLst>
          </p:cNvPr>
          <p:cNvSpPr/>
          <p:nvPr/>
        </p:nvSpPr>
        <p:spPr>
          <a:xfrm>
            <a:off x="5705803" y="4193629"/>
            <a:ext cx="733096" cy="252248"/>
          </a:xfrm>
          <a:prstGeom prst="rect">
            <a:avLst/>
          </a:prstGeom>
          <a:noFill/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9BCE5695-BAEC-4EE2-B312-865C064A6DB1}"/>
              </a:ext>
            </a:extLst>
          </p:cNvPr>
          <p:cNvSpPr/>
          <p:nvPr/>
        </p:nvSpPr>
        <p:spPr>
          <a:xfrm>
            <a:off x="787682" y="-106941"/>
            <a:ext cx="11263020" cy="92333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altLang="zh-CN" sz="54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Full unedited blot/gel for Figure S13E</a:t>
            </a:r>
            <a:endParaRPr lang="zh-CN" altLang="en-US" sz="5400" b="0" cap="none" spc="0" dirty="0">
              <a:ln w="0"/>
              <a:solidFill>
                <a:schemeClr val="accent1"/>
              </a:solidFill>
              <a:effectLst>
                <a:outerShdw blurRad="38100" dist="25400" dir="5400000" algn="ctr" rotWithShape="0">
                  <a:srgbClr val="6E747A">
                    <a:alpha val="43000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25456916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32</Words>
  <Application>Microsoft Office PowerPoint</Application>
  <PresentationFormat>宽屏</PresentationFormat>
  <Paragraphs>4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Administrator</cp:lastModifiedBy>
  <cp:revision>6</cp:revision>
  <dcterms:created xsi:type="dcterms:W3CDTF">2023-07-26T09:34:10Z</dcterms:created>
  <dcterms:modified xsi:type="dcterms:W3CDTF">2023-11-13T14:20:39Z</dcterms:modified>
</cp:coreProperties>
</file>